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48" d="100"/>
          <a:sy n="48" d="100"/>
        </p:scale>
        <p:origin x="29" y="87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2FAE2-B598-4CC3-8D1B-6AB50DFCE5A9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D0420-F47F-4301-80A1-5BBFBFB912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753071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2FAE2-B598-4CC3-8D1B-6AB50DFCE5A9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D0420-F47F-4301-80A1-5BBFBFB912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04363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2FAE2-B598-4CC3-8D1B-6AB50DFCE5A9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D0420-F47F-4301-80A1-5BBFBFB912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37056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2FAE2-B598-4CC3-8D1B-6AB50DFCE5A9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D0420-F47F-4301-80A1-5BBFBFB912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44556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2FAE2-B598-4CC3-8D1B-6AB50DFCE5A9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D0420-F47F-4301-80A1-5BBFBFB912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314073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2FAE2-B598-4CC3-8D1B-6AB50DFCE5A9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D0420-F47F-4301-80A1-5BBFBFB912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8607789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2FAE2-B598-4CC3-8D1B-6AB50DFCE5A9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D0420-F47F-4301-80A1-5BBFBFB912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44549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2FAE2-B598-4CC3-8D1B-6AB50DFCE5A9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D0420-F47F-4301-80A1-5BBFBFB912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3286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2FAE2-B598-4CC3-8D1B-6AB50DFCE5A9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D0420-F47F-4301-80A1-5BBFBFB912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841395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2FAE2-B598-4CC3-8D1B-6AB50DFCE5A9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D0420-F47F-4301-80A1-5BBFBFB912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68256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2FAE2-B598-4CC3-8D1B-6AB50DFCE5A9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4D0420-F47F-4301-80A1-5BBFBFB912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08036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E2FAE2-B598-4CC3-8D1B-6AB50DFCE5A9}" type="datetimeFigureOut">
              <a:rPr lang="en-US" smtClean="0"/>
              <a:t>04/Aug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4D0420-F47F-4301-80A1-5BBFBFB912D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6991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endParaRPr lang="en-US"/>
          </a:p>
        </p:txBody>
      </p:sp>
      <p:pic>
        <p:nvPicPr>
          <p:cNvPr id="4" name="Picture 3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780982" y="1449070"/>
            <a:ext cx="6630035" cy="3959860"/>
          </a:xfrm>
          <a:prstGeom prst="rect">
            <a:avLst/>
          </a:prstGeom>
          <a:noFill/>
          <a:ln>
            <a:noFill/>
          </a:ln>
        </p:spPr>
      </p:pic>
      <p:pic>
        <p:nvPicPr>
          <p:cNvPr id="5" name="Picture 4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83773" y="505097"/>
            <a:ext cx="9249908" cy="5064941"/>
          </a:xfrm>
          <a:prstGeom prst="rect">
            <a:avLst/>
          </a:prstGeom>
          <a:noFill/>
          <a:ln>
            <a:noFill/>
          </a:ln>
        </p:spPr>
      </p:pic>
      <p:sp>
        <p:nvSpPr>
          <p:cNvPr id="7" name="Rectangle 1"/>
          <p:cNvSpPr>
            <a:spLocks noChangeArrowheads="1"/>
          </p:cNvSpPr>
          <p:nvPr/>
        </p:nvSpPr>
        <p:spPr bwMode="auto">
          <a:xfrm>
            <a:off x="783773" y="5807597"/>
            <a:ext cx="12192000" cy="457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none" lIns="91440" tIns="45720" rIns="91440" bIns="45720" numCol="1" anchor="ctr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1200" b="1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Figure S10.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Correlation between β-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haematin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inhibition activity (log(BIHA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)) and </a:t>
            </a:r>
            <a:r>
              <a:rPr kumimoji="0" lang="en-US" altLang="en-US" sz="1200" b="0" i="0" u="sng" strike="noStrike" cap="none" normalizeH="0" baseline="0" smtClean="0">
                <a:ln>
                  <a:noFill/>
                </a:ln>
                <a:solidFill>
                  <a:srgbClr val="008080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anti-malarial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 activity (log(IC</a:t>
            </a:r>
            <a:r>
              <a:rPr kumimoji="0" lang="en-US" altLang="en-US" sz="1200" b="0" i="0" u="none" strike="noStrike" cap="none" normalizeH="0" baseline="-3000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50</a:t>
            </a:r>
            <a:r>
              <a:rPr kumimoji="0" lang="en-US" altLang="en-US" sz="1200" b="0" i="0" u="none" strike="noStrike" cap="none" normalizeH="0" baseline="0" smtClean="0">
                <a:ln>
                  <a:noFill/>
                </a:ln>
                <a:solidFill>
                  <a:srgbClr val="0D0D0D"/>
                </a:solidFill>
                <a:effectLst/>
                <a:latin typeface="Times New Roman" panose="02020603050405020304" pitchFamily="18" charset="0"/>
                <a:ea typeface="MS Mincho"/>
                <a:cs typeface="Times New Roman" panose="02020603050405020304" pitchFamily="18" charset="0"/>
              </a:rPr>
              <a:t>­)) for benzylate chloroquinolines against sensitive strain W2</a:t>
            </a:r>
            <a:r>
              <a:rPr kumimoji="0" lang="en-US" altLang="en-US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</a:rPr>
              <a:t> </a:t>
            </a:r>
            <a:endParaRPr kumimoji="0" lang="en-US" altLang="en-US" sz="1800" b="0" i="0" u="none" strike="noStrike" cap="none" normalizeH="0" baseline="0" smtClean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24761551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4</Words>
  <Application>Microsoft Office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MS Mincho</vt:lpstr>
      <vt:lpstr>Times New Roman</vt:lpstr>
      <vt:lpstr>Office Theme</vt:lpstr>
      <vt:lpstr>PowerPoint Presentation</vt:lpstr>
    </vt:vector>
  </TitlesOfParts>
  <Company>Microsoft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goc Nguyen</dc:creator>
  <cp:lastModifiedBy>Ngoc Nguyen</cp:lastModifiedBy>
  <cp:revision>2</cp:revision>
  <dcterms:created xsi:type="dcterms:W3CDTF">2020-07-03T16:00:18Z</dcterms:created>
  <dcterms:modified xsi:type="dcterms:W3CDTF">2020-08-04T16:32:34Z</dcterms:modified>
</cp:coreProperties>
</file>